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12801600" cy="96012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951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tchell Mostina" userId="7da988d43ede0b4f" providerId="LiveId" clId="{99E91B24-3230-4EB3-8D0B-C9144AECDEB2}"/>
    <pc:docChg chg="undo custSel modSld">
      <pc:chgData name="Mitchell Mostina" userId="7da988d43ede0b4f" providerId="LiveId" clId="{99E91B24-3230-4EB3-8D0B-C9144AECDEB2}" dt="2025-03-20T08:00:20.609" v="261"/>
      <pc:docMkLst>
        <pc:docMk/>
      </pc:docMkLst>
      <pc:sldChg chg="addSp delSp modSp mod addAnim delAnim modAnim">
        <pc:chgData name="Mitchell Mostina" userId="7da988d43ede0b4f" providerId="LiveId" clId="{99E91B24-3230-4EB3-8D0B-C9144AECDEB2}" dt="2025-03-20T08:00:20.609" v="261"/>
        <pc:sldMkLst>
          <pc:docMk/>
          <pc:sldMk cId="2820292753" sldId="256"/>
        </pc:sldMkLst>
        <pc:spChg chg="mod">
          <ac:chgData name="Mitchell Mostina" userId="7da988d43ede0b4f" providerId="LiveId" clId="{99E91B24-3230-4EB3-8D0B-C9144AECDEB2}" dt="2025-03-15T09:35:30.263" v="76" actId="20577"/>
          <ac:spMkLst>
            <pc:docMk/>
            <pc:sldMk cId="2820292753" sldId="256"/>
            <ac:spMk id="2" creationId="{308DFDD2-A6AF-DE48-65D2-9F28D52936AC}"/>
          </ac:spMkLst>
        </pc:spChg>
        <pc:spChg chg="add del mod ord">
          <ac:chgData name="Mitchell Mostina" userId="7da988d43ede0b4f" providerId="LiveId" clId="{99E91B24-3230-4EB3-8D0B-C9144AECDEB2}" dt="2025-03-20T07:57:31.123" v="170" actId="478"/>
          <ac:spMkLst>
            <pc:docMk/>
            <pc:sldMk cId="2820292753" sldId="256"/>
            <ac:spMk id="7" creationId="{6F7A6E76-B972-DAC9-59F0-69CF438FF288}"/>
          </ac:spMkLst>
        </pc:spChg>
        <pc:spChg chg="add del mod">
          <ac:chgData name="Mitchell Mostina" userId="7da988d43ede0b4f" providerId="LiveId" clId="{99E91B24-3230-4EB3-8D0B-C9144AECDEB2}" dt="2025-03-20T07:58:41.194" v="192" actId="478"/>
          <ac:spMkLst>
            <pc:docMk/>
            <pc:sldMk cId="2820292753" sldId="256"/>
            <ac:spMk id="11" creationId="{BA5B00C7-2A7D-EC78-A1DE-09DCE7486E31}"/>
          </ac:spMkLst>
        </pc:spChg>
        <pc:spChg chg="add mod">
          <ac:chgData name="Mitchell Mostina" userId="7da988d43ede0b4f" providerId="LiveId" clId="{99E91B24-3230-4EB3-8D0B-C9144AECDEB2}" dt="2025-03-20T07:59:54.813" v="243" actId="1076"/>
          <ac:spMkLst>
            <pc:docMk/>
            <pc:sldMk cId="2820292753" sldId="256"/>
            <ac:spMk id="12" creationId="{6C30800A-31CC-B3E2-4B03-82F968E2BBB9}"/>
          </ac:spMkLst>
        </pc:spChg>
        <pc:picChg chg="add del mod">
          <ac:chgData name="Mitchell Mostina" userId="7da988d43ede0b4f" providerId="LiveId" clId="{99E91B24-3230-4EB3-8D0B-C9144AECDEB2}" dt="2025-03-20T07:58:43.972" v="196" actId="478"/>
          <ac:picMkLst>
            <pc:docMk/>
            <pc:sldMk cId="2820292753" sldId="256"/>
            <ac:picMk id="8" creationId="{0D5B109D-8BB3-8A4F-43A1-AA7D4B79F55D}"/>
          </ac:picMkLst>
        </pc:picChg>
        <pc:cxnChg chg="add del mod ord">
          <ac:chgData name="Mitchell Mostina" userId="7da988d43ede0b4f" providerId="LiveId" clId="{99E91B24-3230-4EB3-8D0B-C9144AECDEB2}" dt="2025-03-20T07:57:34.520" v="173" actId="478"/>
          <ac:cxnSpMkLst>
            <pc:docMk/>
            <pc:sldMk cId="2820292753" sldId="256"/>
            <ac:cxnSpMk id="4" creationId="{DB610599-423F-B41C-B70F-C4C8F15BF020}"/>
          </ac:cxnSpMkLst>
        </pc:cxnChg>
        <pc:cxnChg chg="add del mod">
          <ac:chgData name="Mitchell Mostina" userId="7da988d43ede0b4f" providerId="LiveId" clId="{99E91B24-3230-4EB3-8D0B-C9144AECDEB2}" dt="2025-03-20T07:58:45.153" v="197" actId="478"/>
          <ac:cxnSpMkLst>
            <pc:docMk/>
            <pc:sldMk cId="2820292753" sldId="256"/>
            <ac:cxnSpMk id="10" creationId="{5E9C58F4-B141-B47F-8601-163BB0286487}"/>
          </ac:cxnSpMkLst>
        </pc:cxnChg>
        <pc:cxnChg chg="add mod">
          <ac:chgData name="Mitchell Mostina" userId="7da988d43ede0b4f" providerId="LiveId" clId="{99E91B24-3230-4EB3-8D0B-C9144AECDEB2}" dt="2025-03-20T08:00:07.184" v="246" actId="1582"/>
          <ac:cxnSpMkLst>
            <pc:docMk/>
            <pc:sldMk cId="2820292753" sldId="256"/>
            <ac:cxnSpMk id="14" creationId="{17FF33D9-6FD5-699F-6780-70DA0FCDF33D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A0DC6D-E047-47BB-99BB-C1B991533067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CFF186-268D-4A59-8D6A-045F8C0972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39475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CFF186-268D-4A59-8D6A-045F8C0972CA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248861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17864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2744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681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01902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>
                    <a:shade val="82000"/>
                  </a:schemeClr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shade val="82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shade val="82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7757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08604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84229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4393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90026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73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9633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shade val="82000"/>
                  </a:schemeClr>
                </a:solidFill>
              </a:defRPr>
            </a:lvl1pPr>
          </a:lstStyle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shade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shade val="82000"/>
                  </a:schemeClr>
                </a:solidFill>
              </a:defRPr>
            </a:lvl1pPr>
          </a:lstStyle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46637376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A237AB9-D56B-A2CA-1AF1-59B6DD3CD5FE}"/>
              </a:ext>
            </a:extLst>
          </p:cNvPr>
          <p:cNvSpPr txBox="1"/>
          <p:nvPr/>
        </p:nvSpPr>
        <p:spPr>
          <a:xfrm>
            <a:off x="0" y="0"/>
            <a:ext cx="84189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</a:p>
          <a:p>
            <a:r>
              <a:rPr lang="en-AU" sz="20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1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08DFDD2-A6AF-DE48-65D2-9F28D52936AC}"/>
              </a:ext>
            </a:extLst>
          </p:cNvPr>
          <p:cNvSpPr txBox="1"/>
          <p:nvPr/>
        </p:nvSpPr>
        <p:spPr>
          <a:xfrm>
            <a:off x="578223" y="8954869"/>
            <a:ext cx="116451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3</a:t>
            </a:r>
            <a:r>
              <a:rPr lang="en-AU" i="1" dirty="0">
                <a:latin typeface="Arial" panose="020B0604020202020204" pitchFamily="34" charset="0"/>
                <a:cs typeface="Arial" panose="020B0604020202020204" pitchFamily="34" charset="0"/>
              </a:rPr>
              <a:t>: Whole mount immunofluorescence – Day 115 P111 human vascularised skin organoid demonstrating perifollicular vascularisation. </a:t>
            </a:r>
          </a:p>
        </p:txBody>
      </p:sp>
      <p:pic>
        <p:nvPicPr>
          <p:cNvPr id="8" name="Video 7">
            <a:hlinkClick r:id="" action="ppaction://media"/>
            <a:extLst>
              <a:ext uri="{FF2B5EF4-FFF2-40B4-BE49-F238E27FC236}">
                <a16:creationId xmlns:a16="http://schemas.microsoft.com/office/drawing/2014/main" id="{0D5B109D-8BB3-8A4F-43A1-AA7D4B79F55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785916" y="532545"/>
            <a:ext cx="11229765" cy="8422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0292753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 mute="1">
                <p:cTn id="2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538D9D"/>
      </a:hlink>
      <a:folHlink>
        <a:srgbClr val="A5738E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3A418E6B-C5F0-4B95-8D77-61E3EF3B5DF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Words>22</Words>
  <Application>Microsoft Office PowerPoint</Application>
  <PresentationFormat>A3 Paper (297x420 mm)</PresentationFormat>
  <Paragraphs>4</Paragraphs>
  <Slides>1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tchell Mostina</dc:creator>
  <cp:lastModifiedBy>Abbas Shafiee</cp:lastModifiedBy>
  <cp:revision>11</cp:revision>
  <dcterms:created xsi:type="dcterms:W3CDTF">2024-06-28T02:38:16Z</dcterms:created>
  <dcterms:modified xsi:type="dcterms:W3CDTF">2025-07-11T07:16:40Z</dcterms:modified>
</cp:coreProperties>
</file>